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76672" y="6660232"/>
            <a:ext cx="59766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Arial" pitchFamily="34" charset="0"/>
                <a:cs typeface="Arial" pitchFamily="34" charset="0"/>
              </a:rPr>
              <a:t>S6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. Mammalian protein-protein interaction trap (MAPPIT) is a cytokine receptor-based mammalian two hybrid method for analysis of protein-protein interactions. 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10" descr="Supp Figure MAPPIT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80728" y="452786"/>
            <a:ext cx="4954222" cy="584740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2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2:20Z</dcterms:modified>
</cp:coreProperties>
</file>